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7DC176-A2E5-4CAA-8E1C-3410D00D930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C12DB7-E80E-45D6-A988-60AF87FF62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79287-E207-4665-A215-B2C5B9C999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B960C-3F37-4646-AB3B-0497D6FC91B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97643A-18DA-450D-81C1-3B6672FEC7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12671F-9AC5-453B-AAB5-CC4D2ADF7E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188A3B-D0EC-45BC-B8C2-FCCAAA77CB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FE4F7-F749-4D5A-BD34-8332995797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41D55B-6745-4A71-BF27-36AE27BC6E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8B88E-C614-4FF6-ACEC-4D1D7AAF4A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37498-EFEB-4068-9A43-7783B9FBF4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317C2-8943-47FC-B1C3-3E5250B3ED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26B3B5E-7235-4C18-A21C-CB21B4D6673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-360"/>
            <a:ext cx="1752480" cy="228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able S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1211040" y="258840"/>
            <a:ext cx="681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able S3: Disease-specific survival rates of proteins that associate with high LMW-E protein leve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" name="Object 6"/>
          <p:cNvGraphicFramePr/>
          <p:nvPr/>
        </p:nvGraphicFramePr>
        <p:xfrm>
          <a:off x="2743200" y="690480"/>
          <a:ext cx="3117960" cy="616752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4" name="Object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743200" y="690480"/>
                    <a:ext cx="3117960" cy="6167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01T16:50:00Z</dcterms:created>
  <dc:creator>Khandan Keyomarsi</dc:creator>
  <dc:description/>
  <dc:language>en-US</dc:language>
  <cp:lastModifiedBy>Khandan Keyomarsi</cp:lastModifiedBy>
  <dcterms:modified xsi:type="dcterms:W3CDTF">2011-12-01T16:50:25Z</dcterms:modified>
  <cp:revision>1</cp:revision>
  <dc:subject/>
  <dc:title>Table S3</dc:title>
</cp:coreProperties>
</file>